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61" r:id="rId2"/>
    <p:sldId id="262" r:id="rId3"/>
    <p:sldId id="269" r:id="rId4"/>
    <p:sldId id="270" r:id="rId5"/>
    <p:sldId id="265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48" autoAdjust="0"/>
    <p:restoredTop sz="94220" autoAdjust="0"/>
  </p:normalViewPr>
  <p:slideViewPr>
    <p:cSldViewPr snapToGrid="0">
      <p:cViewPr varScale="1">
        <p:scale>
          <a:sx n="104" d="100"/>
          <a:sy n="104" d="100"/>
        </p:scale>
        <p:origin x="6906" y="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25766-C0FB-4FAD-AC56-C6577F1E0B5F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2EF1C2-FB5A-45B6-8E94-937912646E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3842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093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062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9548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4049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1106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7712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4400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9018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075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0553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9093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2451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F7C1F76E-0779-465F-8775-4383DC690561}"/>
              </a:ext>
            </a:extLst>
          </p:cNvPr>
          <p:cNvGrpSpPr/>
          <p:nvPr/>
        </p:nvGrpSpPr>
        <p:grpSpPr>
          <a:xfrm>
            <a:off x="363070" y="266312"/>
            <a:ext cx="6131859" cy="8888420"/>
            <a:chOff x="394447" y="875912"/>
            <a:chExt cx="6131859" cy="8888420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677768EF-5FBE-42E1-BE44-D9973CAA4DFC}"/>
                </a:ext>
              </a:extLst>
            </p:cNvPr>
            <p:cNvSpPr txBox="1"/>
            <p:nvPr/>
          </p:nvSpPr>
          <p:spPr>
            <a:xfrm>
              <a:off x="1065480" y="875912"/>
              <a:ext cx="197842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</a:p>
            <a:p>
              <a:pPr algn="ctr"/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up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R1min to R0m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8DE0D72E-821E-4615-8874-C0AAC14CE683}"/>
                </a:ext>
              </a:extLst>
            </p:cNvPr>
            <p:cNvSpPr txBox="1"/>
            <p:nvPr/>
          </p:nvSpPr>
          <p:spPr>
            <a:xfrm>
              <a:off x="4021288" y="875912"/>
              <a:ext cx="208101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own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R1min to R0m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53EC1B4E-2665-4E4F-8895-3C0C394F7E09}"/>
                </a:ext>
              </a:extLst>
            </p:cNvPr>
            <p:cNvSpPr txBox="1"/>
            <p:nvPr/>
          </p:nvSpPr>
          <p:spPr>
            <a:xfrm>
              <a:off x="494380" y="914384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673EEF2F-08E9-4CFE-83CA-7347386B0D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798"/>
            <a:stretch/>
          </p:blipFill>
          <p:spPr>
            <a:xfrm>
              <a:off x="3722692" y="1237423"/>
              <a:ext cx="2667153" cy="2584420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87CDE14D-E6BF-4DDC-96EF-37C1D29392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460"/>
            <a:stretch/>
          </p:blipFill>
          <p:spPr>
            <a:xfrm>
              <a:off x="464039" y="1237423"/>
              <a:ext cx="2987041" cy="2576801"/>
            </a:xfrm>
            <a:prstGeom prst="rect">
              <a:avLst/>
            </a:prstGeom>
          </p:spPr>
        </p:pic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24F6C874-292F-4426-B973-76D9196588DB}"/>
                </a:ext>
              </a:extLst>
            </p:cNvPr>
            <p:cNvSpPr txBox="1"/>
            <p:nvPr/>
          </p:nvSpPr>
          <p:spPr>
            <a:xfrm>
              <a:off x="1065480" y="3842160"/>
              <a:ext cx="200728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up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R30min to R0m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05636D1B-917E-48A5-AD5B-30C8CAD916A5}"/>
                </a:ext>
              </a:extLst>
            </p:cNvPr>
            <p:cNvSpPr txBox="1"/>
            <p:nvPr/>
          </p:nvSpPr>
          <p:spPr>
            <a:xfrm>
              <a:off x="3990442" y="3834012"/>
              <a:ext cx="213872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own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R30min to R0m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387D1D1B-CA30-4269-B4F8-0C8FFD790399}"/>
                </a:ext>
              </a:extLst>
            </p:cNvPr>
            <p:cNvSpPr txBox="1"/>
            <p:nvPr/>
          </p:nvSpPr>
          <p:spPr>
            <a:xfrm>
              <a:off x="496605" y="3876728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3784C7FF-10B8-4C00-918A-E647FACC16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507"/>
            <a:stretch/>
          </p:blipFill>
          <p:spPr>
            <a:xfrm>
              <a:off x="3767200" y="4200842"/>
              <a:ext cx="2660847" cy="2586164"/>
            </a:xfrm>
            <a:prstGeom prst="rect">
              <a:avLst/>
            </a:prstGeom>
          </p:spPr>
        </p:pic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93C04C78-EF70-4A5D-9F32-2A2BEE0ECB7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507"/>
            <a:stretch/>
          </p:blipFill>
          <p:spPr>
            <a:xfrm>
              <a:off x="889097" y="4200842"/>
              <a:ext cx="2525435" cy="2586164"/>
            </a:xfrm>
            <a:prstGeom prst="rect">
              <a:avLst/>
            </a:prstGeom>
          </p:spPr>
        </p:pic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E4E20086-58DD-4009-AADE-C9D040B91C5A}"/>
                </a:ext>
              </a:extLst>
            </p:cNvPr>
            <p:cNvSpPr txBox="1"/>
            <p:nvPr/>
          </p:nvSpPr>
          <p:spPr>
            <a:xfrm>
              <a:off x="1065480" y="6811294"/>
              <a:ext cx="200728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up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R45min to R0m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F6A9B39B-5161-4723-946A-27DD80668879}"/>
                </a:ext>
              </a:extLst>
            </p:cNvPr>
            <p:cNvSpPr txBox="1"/>
            <p:nvPr/>
          </p:nvSpPr>
          <p:spPr>
            <a:xfrm>
              <a:off x="3961587" y="6811294"/>
              <a:ext cx="216758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</a:p>
            <a:p>
              <a:pPr algn="ctr"/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own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R45min to R0m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87002FEC-68B0-4B51-88AB-71BE88F5A851}"/>
                </a:ext>
              </a:extLst>
            </p:cNvPr>
            <p:cNvSpPr txBox="1"/>
            <p:nvPr/>
          </p:nvSpPr>
          <p:spPr>
            <a:xfrm>
              <a:off x="490373" y="6852189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2B6AC9C2-8B25-42DC-9EEB-336357725D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5" t="4309"/>
            <a:stretch/>
          </p:blipFill>
          <p:spPr>
            <a:xfrm>
              <a:off x="3735333" y="7174136"/>
              <a:ext cx="2673877" cy="2590196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0DF1E6F8-7080-4331-A7C4-8B795A09D1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111"/>
            <a:stretch/>
          </p:blipFill>
          <p:spPr>
            <a:xfrm>
              <a:off x="564927" y="7149848"/>
              <a:ext cx="2849605" cy="2605437"/>
            </a:xfrm>
            <a:prstGeom prst="rect">
              <a:avLst/>
            </a:prstGeom>
          </p:spPr>
        </p:pic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3350DFAD-B738-4D4E-950C-B3E0C17173F8}"/>
                </a:ext>
              </a:extLst>
            </p:cNvPr>
            <p:cNvSpPr/>
            <p:nvPr/>
          </p:nvSpPr>
          <p:spPr>
            <a:xfrm>
              <a:off x="394447" y="875912"/>
              <a:ext cx="6131859" cy="2922051"/>
            </a:xfrm>
            <a:prstGeom prst="rect">
              <a:avLst/>
            </a:prstGeom>
            <a:noFill/>
            <a:ln w="1905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3249B74F-52D5-428E-AB62-7E87F4A33EE5}"/>
                </a:ext>
              </a:extLst>
            </p:cNvPr>
            <p:cNvSpPr/>
            <p:nvPr/>
          </p:nvSpPr>
          <p:spPr>
            <a:xfrm>
              <a:off x="394447" y="3853479"/>
              <a:ext cx="6131859" cy="2922051"/>
            </a:xfrm>
            <a:prstGeom prst="rect">
              <a:avLst/>
            </a:prstGeom>
            <a:noFill/>
            <a:ln w="1905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EBC7CFF0-3D45-4845-9869-40C98D1111B9}"/>
                </a:ext>
              </a:extLst>
            </p:cNvPr>
            <p:cNvSpPr/>
            <p:nvPr/>
          </p:nvSpPr>
          <p:spPr>
            <a:xfrm>
              <a:off x="394447" y="6840782"/>
              <a:ext cx="6131859" cy="2922051"/>
            </a:xfrm>
            <a:prstGeom prst="rect">
              <a:avLst/>
            </a:prstGeom>
            <a:noFill/>
            <a:ln w="1905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8288168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773E0815-4F4A-410B-9F90-75C8305F6CB6}"/>
              </a:ext>
            </a:extLst>
          </p:cNvPr>
          <p:cNvSpPr txBox="1"/>
          <p:nvPr/>
        </p:nvSpPr>
        <p:spPr>
          <a:xfrm>
            <a:off x="974690" y="350059"/>
            <a:ext cx="18710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</a:p>
          <a:p>
            <a:pPr algn="ctr"/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p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6h to R0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ECBF6A3-3CF3-45AC-810F-0E8759774661}"/>
              </a:ext>
            </a:extLst>
          </p:cNvPr>
          <p:cNvSpPr txBox="1"/>
          <p:nvPr/>
        </p:nvSpPr>
        <p:spPr>
          <a:xfrm>
            <a:off x="3807011" y="349183"/>
            <a:ext cx="19736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own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6h to R0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7E6E1495-8ED6-46E0-92A8-6A70E47BBD09}"/>
              </a:ext>
            </a:extLst>
          </p:cNvPr>
          <p:cNvSpPr txBox="1"/>
          <p:nvPr/>
        </p:nvSpPr>
        <p:spPr>
          <a:xfrm>
            <a:off x="321524" y="373220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6176E592-D8BF-4CD7-91E5-1B0966DC9AA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42"/>
          <a:stretch/>
        </p:blipFill>
        <p:spPr>
          <a:xfrm>
            <a:off x="3451227" y="693900"/>
            <a:ext cx="2685184" cy="2583132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2E21B889-5654-456B-829A-591236064B6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42"/>
          <a:stretch/>
        </p:blipFill>
        <p:spPr>
          <a:xfrm>
            <a:off x="457713" y="709233"/>
            <a:ext cx="2840946" cy="2583132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0930BEE1-17E2-4353-A1D5-B7F201ACC2B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92" b="1"/>
          <a:stretch/>
        </p:blipFill>
        <p:spPr>
          <a:xfrm>
            <a:off x="447151" y="3694163"/>
            <a:ext cx="2880000" cy="2594222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A7CD20E6-A7E2-4E19-BC99-B24B781FA79C}"/>
              </a:ext>
            </a:extLst>
          </p:cNvPr>
          <p:cNvSpPr txBox="1"/>
          <p:nvPr/>
        </p:nvSpPr>
        <p:spPr>
          <a:xfrm>
            <a:off x="1003979" y="3351435"/>
            <a:ext cx="18421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p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1d to R0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F782515-2852-465E-BF0B-04AA291DAEEF}"/>
              </a:ext>
            </a:extLst>
          </p:cNvPr>
          <p:cNvSpPr txBox="1"/>
          <p:nvPr/>
        </p:nvSpPr>
        <p:spPr>
          <a:xfrm>
            <a:off x="3805666" y="3351435"/>
            <a:ext cx="19736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own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1d to R0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ED732D1-A00D-4B9F-ABB5-29A68502A7E0}"/>
              </a:ext>
            </a:extLst>
          </p:cNvPr>
          <p:cNvSpPr txBox="1"/>
          <p:nvPr/>
        </p:nvSpPr>
        <p:spPr>
          <a:xfrm>
            <a:off x="321524" y="3387388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53FEB029-6200-46C5-A6DE-27F24CB3D98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62"/>
          <a:stretch/>
        </p:blipFill>
        <p:spPr>
          <a:xfrm>
            <a:off x="3407307" y="3695381"/>
            <a:ext cx="2777453" cy="2623091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B11F1B2A-AE03-46A2-9930-70905AE556EC}"/>
              </a:ext>
            </a:extLst>
          </p:cNvPr>
          <p:cNvSpPr txBox="1"/>
          <p:nvPr/>
        </p:nvSpPr>
        <p:spPr>
          <a:xfrm>
            <a:off x="889067" y="6297073"/>
            <a:ext cx="20361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</a:p>
          <a:p>
            <a:pPr algn="ctr"/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p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30min to R1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0A08A3A-F111-4718-AABC-E2EA45C73C39}"/>
              </a:ext>
            </a:extLst>
          </p:cNvPr>
          <p:cNvSpPr txBox="1"/>
          <p:nvPr/>
        </p:nvSpPr>
        <p:spPr>
          <a:xfrm>
            <a:off x="3693731" y="6292514"/>
            <a:ext cx="21675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</a:p>
          <a:p>
            <a:pPr algn="ctr"/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own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30min to R1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FB7F88C-CDF9-496C-8D4A-6F813489BEAE}"/>
              </a:ext>
            </a:extLst>
          </p:cNvPr>
          <p:cNvSpPr txBox="1"/>
          <p:nvPr/>
        </p:nvSpPr>
        <p:spPr>
          <a:xfrm>
            <a:off x="346383" y="6333550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F22EB687-E87C-46D4-88C8-38CF2BF68A5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76"/>
          <a:stretch/>
        </p:blipFill>
        <p:spPr>
          <a:xfrm>
            <a:off x="3244730" y="6635784"/>
            <a:ext cx="2857500" cy="2589274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45F47A80-4B2F-40A9-B397-06B29ED2060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18"/>
          <a:stretch/>
        </p:blipFill>
        <p:spPr>
          <a:xfrm>
            <a:off x="615492" y="6635784"/>
            <a:ext cx="2661560" cy="2589274"/>
          </a:xfrm>
          <a:prstGeom prst="rect">
            <a:avLst/>
          </a:prstGeom>
        </p:spPr>
      </p:pic>
      <p:sp>
        <p:nvSpPr>
          <p:cNvPr id="25" name="矩形 24">
            <a:extLst>
              <a:ext uri="{FF2B5EF4-FFF2-40B4-BE49-F238E27FC236}">
                <a16:creationId xmlns:a16="http://schemas.microsoft.com/office/drawing/2014/main" id="{E803E7DC-B0F9-4734-96DA-ABED13460DF3}"/>
              </a:ext>
            </a:extLst>
          </p:cNvPr>
          <p:cNvSpPr/>
          <p:nvPr/>
        </p:nvSpPr>
        <p:spPr>
          <a:xfrm>
            <a:off x="349622" y="355959"/>
            <a:ext cx="6131859" cy="2922051"/>
          </a:xfrm>
          <a:prstGeom prst="rect">
            <a:avLst/>
          </a:prstGeom>
          <a:noFill/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E237611E-FAA5-4A39-A5EF-428488754380}"/>
              </a:ext>
            </a:extLst>
          </p:cNvPr>
          <p:cNvSpPr/>
          <p:nvPr/>
        </p:nvSpPr>
        <p:spPr>
          <a:xfrm>
            <a:off x="349622" y="3333526"/>
            <a:ext cx="6131859" cy="2922051"/>
          </a:xfrm>
          <a:prstGeom prst="rect">
            <a:avLst/>
          </a:prstGeom>
          <a:noFill/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65F74757-60B7-45F5-B913-B71541EF5639}"/>
              </a:ext>
            </a:extLst>
          </p:cNvPr>
          <p:cNvSpPr/>
          <p:nvPr/>
        </p:nvSpPr>
        <p:spPr>
          <a:xfrm>
            <a:off x="349622" y="6320829"/>
            <a:ext cx="6131859" cy="2922051"/>
          </a:xfrm>
          <a:prstGeom prst="rect">
            <a:avLst/>
          </a:prstGeom>
          <a:noFill/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47027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1100658D-800A-4047-B3DF-5E16F40CF682}"/>
              </a:ext>
            </a:extLst>
          </p:cNvPr>
          <p:cNvSpPr txBox="1"/>
          <p:nvPr/>
        </p:nvSpPr>
        <p:spPr>
          <a:xfrm>
            <a:off x="885156" y="393661"/>
            <a:ext cx="20361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</a:p>
          <a:p>
            <a:pPr algn="ctr"/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p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45min to R1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6F6B2A2-B970-4BF8-AAB4-7EB0B1BEB2CD}"/>
              </a:ext>
            </a:extLst>
          </p:cNvPr>
          <p:cNvSpPr txBox="1"/>
          <p:nvPr/>
        </p:nvSpPr>
        <p:spPr>
          <a:xfrm>
            <a:off x="3980697" y="393659"/>
            <a:ext cx="21387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own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45min to R1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86E9CC4D-E8F5-4679-81FE-E3D8A84991AB}"/>
              </a:ext>
            </a:extLst>
          </p:cNvPr>
          <p:cNvSpPr txBox="1"/>
          <p:nvPr/>
        </p:nvSpPr>
        <p:spPr>
          <a:xfrm>
            <a:off x="409378" y="435014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D523CC19-283E-4006-AEBE-C093F8FA00C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91"/>
          <a:stretch/>
        </p:blipFill>
        <p:spPr>
          <a:xfrm>
            <a:off x="3507967" y="757965"/>
            <a:ext cx="2994659" cy="2579843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6418A787-80ED-4535-9217-0440726B64B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84"/>
          <a:stretch/>
        </p:blipFill>
        <p:spPr>
          <a:xfrm>
            <a:off x="443306" y="757966"/>
            <a:ext cx="2872740" cy="2579843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BD8043AF-3957-464F-AE2D-7BEFF6EC3F71}"/>
              </a:ext>
            </a:extLst>
          </p:cNvPr>
          <p:cNvSpPr txBox="1"/>
          <p:nvPr/>
        </p:nvSpPr>
        <p:spPr>
          <a:xfrm>
            <a:off x="970557" y="3363560"/>
            <a:ext cx="18710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</a:p>
          <a:p>
            <a:pPr algn="ctr"/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p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6h to R1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22D307D-23FA-4EFA-AAC8-A8D8420B08F8}"/>
              </a:ext>
            </a:extLst>
          </p:cNvPr>
          <p:cNvSpPr txBox="1"/>
          <p:nvPr/>
        </p:nvSpPr>
        <p:spPr>
          <a:xfrm>
            <a:off x="4034487" y="3363560"/>
            <a:ext cx="20024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</a:p>
          <a:p>
            <a:pPr algn="ctr"/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own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6h to R1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A981A8E4-58C4-4459-8C5B-62C242EB919A}"/>
              </a:ext>
            </a:extLst>
          </p:cNvPr>
          <p:cNvSpPr txBox="1"/>
          <p:nvPr/>
        </p:nvSpPr>
        <p:spPr>
          <a:xfrm>
            <a:off x="403424" y="3399151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23FBD8EB-DD3F-4EB8-B75D-E1F02471603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53"/>
          <a:stretch/>
        </p:blipFill>
        <p:spPr>
          <a:xfrm>
            <a:off x="3436387" y="3733962"/>
            <a:ext cx="2994660" cy="2580856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E604DC38-0D5E-4997-BB25-84A5F8B7ADD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12"/>
          <a:stretch/>
        </p:blipFill>
        <p:spPr>
          <a:xfrm>
            <a:off x="462813" y="3722103"/>
            <a:ext cx="2759476" cy="2588476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B57384E5-741B-420E-8D10-E81C5F44B998}"/>
              </a:ext>
            </a:extLst>
          </p:cNvPr>
          <p:cNvSpPr txBox="1"/>
          <p:nvPr/>
        </p:nvSpPr>
        <p:spPr>
          <a:xfrm>
            <a:off x="975932" y="6331808"/>
            <a:ext cx="18710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</a:p>
          <a:p>
            <a:pPr algn="ctr"/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p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1d to R1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570ECE14-6505-4FD7-84BB-A354A354F782}"/>
              </a:ext>
            </a:extLst>
          </p:cNvPr>
          <p:cNvSpPr txBox="1"/>
          <p:nvPr/>
        </p:nvSpPr>
        <p:spPr>
          <a:xfrm>
            <a:off x="4047194" y="6333481"/>
            <a:ext cx="19736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own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1d to R1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8B620FDC-79AB-44AC-84A8-C66D83D85DDE}"/>
              </a:ext>
            </a:extLst>
          </p:cNvPr>
          <p:cNvSpPr txBox="1"/>
          <p:nvPr/>
        </p:nvSpPr>
        <p:spPr>
          <a:xfrm>
            <a:off x="435484" y="6347410"/>
            <a:ext cx="2231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62AABF33-C775-4925-8E7E-EC4627FD7FB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81"/>
          <a:stretch/>
        </p:blipFill>
        <p:spPr>
          <a:xfrm>
            <a:off x="3507529" y="6670361"/>
            <a:ext cx="2995097" cy="2591315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B133AFE5-769B-4FF2-8F33-47C1443D3C4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81"/>
          <a:stretch/>
        </p:blipFill>
        <p:spPr>
          <a:xfrm>
            <a:off x="454891" y="6670362"/>
            <a:ext cx="2836216" cy="2591315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75F1AD04-8C94-469C-A332-D5D97AC15A80}"/>
              </a:ext>
            </a:extLst>
          </p:cNvPr>
          <p:cNvSpPr/>
          <p:nvPr/>
        </p:nvSpPr>
        <p:spPr>
          <a:xfrm>
            <a:off x="394447" y="400784"/>
            <a:ext cx="6131859" cy="2922051"/>
          </a:xfrm>
          <a:prstGeom prst="rect">
            <a:avLst/>
          </a:prstGeom>
          <a:noFill/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AAFECBA8-7EA4-4853-A555-222843067A50}"/>
              </a:ext>
            </a:extLst>
          </p:cNvPr>
          <p:cNvSpPr/>
          <p:nvPr/>
        </p:nvSpPr>
        <p:spPr>
          <a:xfrm>
            <a:off x="394447" y="3378351"/>
            <a:ext cx="6131859" cy="2922051"/>
          </a:xfrm>
          <a:prstGeom prst="rect">
            <a:avLst/>
          </a:prstGeom>
          <a:noFill/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0FD2632D-325E-48A2-B11F-801E3A2F8A0A}"/>
              </a:ext>
            </a:extLst>
          </p:cNvPr>
          <p:cNvSpPr/>
          <p:nvPr/>
        </p:nvSpPr>
        <p:spPr>
          <a:xfrm>
            <a:off x="394447" y="6365654"/>
            <a:ext cx="6131859" cy="2922051"/>
          </a:xfrm>
          <a:prstGeom prst="rect">
            <a:avLst/>
          </a:prstGeom>
          <a:noFill/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04485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图片 24">
            <a:extLst>
              <a:ext uri="{FF2B5EF4-FFF2-40B4-BE49-F238E27FC236}">
                <a16:creationId xmlns:a16="http://schemas.microsoft.com/office/drawing/2014/main" id="{8D6C9206-4742-4FAF-B0CD-4F70B13E778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18"/>
          <a:stretch/>
        </p:blipFill>
        <p:spPr>
          <a:xfrm>
            <a:off x="572898" y="6789918"/>
            <a:ext cx="2714166" cy="259152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91A68384-F75A-41BB-BF12-9C70A4F58F50}"/>
              </a:ext>
            </a:extLst>
          </p:cNvPr>
          <p:cNvSpPr txBox="1"/>
          <p:nvPr/>
        </p:nvSpPr>
        <p:spPr>
          <a:xfrm>
            <a:off x="892579" y="401478"/>
            <a:ext cx="20649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p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45min to R30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873DD7B5-00BD-43D6-9B43-67134D6D2952}"/>
              </a:ext>
            </a:extLst>
          </p:cNvPr>
          <p:cNvSpPr txBox="1"/>
          <p:nvPr/>
        </p:nvSpPr>
        <p:spPr>
          <a:xfrm>
            <a:off x="3768987" y="395118"/>
            <a:ext cx="21964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own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45min to R30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474F403-FEB1-42FD-B7B0-B2172F174DFB}"/>
              </a:ext>
            </a:extLst>
          </p:cNvPr>
          <p:cNvSpPr txBox="1"/>
          <p:nvPr/>
        </p:nvSpPr>
        <p:spPr>
          <a:xfrm>
            <a:off x="493476" y="436078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3B7BD490-B04A-4121-8431-3466B4D7D7F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82"/>
          <a:stretch/>
        </p:blipFill>
        <p:spPr>
          <a:xfrm>
            <a:off x="3540145" y="763344"/>
            <a:ext cx="2654117" cy="2588432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AE992A6F-334A-4869-8A8D-EDE7BD94F2B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82"/>
          <a:stretch/>
        </p:blipFill>
        <p:spPr>
          <a:xfrm>
            <a:off x="614063" y="763344"/>
            <a:ext cx="2654118" cy="2588432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39EBD380-DC2F-4E90-89AA-CD4C27E1F577}"/>
              </a:ext>
            </a:extLst>
          </p:cNvPr>
          <p:cNvSpPr txBox="1"/>
          <p:nvPr/>
        </p:nvSpPr>
        <p:spPr>
          <a:xfrm>
            <a:off x="941819" y="3381572"/>
            <a:ext cx="19287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</a:p>
          <a:p>
            <a:pPr algn="ctr"/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p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6h to R30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F67C2C6-5CF8-4378-BFD8-856C0BBAF816}"/>
              </a:ext>
            </a:extLst>
          </p:cNvPr>
          <p:cNvSpPr txBox="1"/>
          <p:nvPr/>
        </p:nvSpPr>
        <p:spPr>
          <a:xfrm>
            <a:off x="3851540" y="3366466"/>
            <a:ext cx="20313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own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6h to R30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536681E-F103-4C62-A781-A8A88B7767E0}"/>
              </a:ext>
            </a:extLst>
          </p:cNvPr>
          <p:cNvSpPr txBox="1"/>
          <p:nvPr/>
        </p:nvSpPr>
        <p:spPr>
          <a:xfrm>
            <a:off x="528511" y="3423146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AC491888-19B1-43C5-AC9D-21498F465DB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98"/>
          <a:stretch/>
        </p:blipFill>
        <p:spPr>
          <a:xfrm>
            <a:off x="3501365" y="3738117"/>
            <a:ext cx="2665583" cy="2593741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CA3E902F-4412-4F97-BCBF-1D4D2AC344D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98"/>
          <a:stretch/>
        </p:blipFill>
        <p:spPr>
          <a:xfrm>
            <a:off x="436931" y="3738117"/>
            <a:ext cx="2891672" cy="2593740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B6FA6981-B526-4E3A-881F-90F799CF23E7}"/>
              </a:ext>
            </a:extLst>
          </p:cNvPr>
          <p:cNvSpPr txBox="1"/>
          <p:nvPr/>
        </p:nvSpPr>
        <p:spPr>
          <a:xfrm>
            <a:off x="971077" y="6428065"/>
            <a:ext cx="18998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p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1d to R30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DCD14C5-D58B-4B35-AD93-3EE58C0492F9}"/>
              </a:ext>
            </a:extLst>
          </p:cNvPr>
          <p:cNvSpPr txBox="1"/>
          <p:nvPr/>
        </p:nvSpPr>
        <p:spPr>
          <a:xfrm>
            <a:off x="3851540" y="6428065"/>
            <a:ext cx="20313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op 20 of KEGG enrichment of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own-regulated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R1d to R30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E58BCC4-024F-436D-85E5-7B911C96A386}"/>
              </a:ext>
            </a:extLst>
          </p:cNvPr>
          <p:cNvSpPr txBox="1"/>
          <p:nvPr/>
        </p:nvSpPr>
        <p:spPr>
          <a:xfrm>
            <a:off x="491294" y="6465965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CE01BF84-1791-46E7-A70F-AE200423A9E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33"/>
          <a:stretch/>
        </p:blipFill>
        <p:spPr>
          <a:xfrm>
            <a:off x="3558075" y="6807848"/>
            <a:ext cx="2659380" cy="2573220"/>
          </a:xfrm>
          <a:prstGeom prst="rect">
            <a:avLst/>
          </a:prstGeom>
        </p:spPr>
      </p:pic>
      <p:sp>
        <p:nvSpPr>
          <p:cNvPr id="26" name="矩形 25">
            <a:extLst>
              <a:ext uri="{FF2B5EF4-FFF2-40B4-BE49-F238E27FC236}">
                <a16:creationId xmlns:a16="http://schemas.microsoft.com/office/drawing/2014/main" id="{402F8B27-775E-42F2-BB49-888E59B7BC3A}"/>
              </a:ext>
            </a:extLst>
          </p:cNvPr>
          <p:cNvSpPr/>
          <p:nvPr/>
        </p:nvSpPr>
        <p:spPr>
          <a:xfrm>
            <a:off x="394447" y="418717"/>
            <a:ext cx="6131859" cy="2922051"/>
          </a:xfrm>
          <a:prstGeom prst="rect">
            <a:avLst/>
          </a:prstGeom>
          <a:noFill/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170D0E2D-0EC9-4BD0-B97E-A1BDCA39CA9C}"/>
              </a:ext>
            </a:extLst>
          </p:cNvPr>
          <p:cNvSpPr/>
          <p:nvPr/>
        </p:nvSpPr>
        <p:spPr>
          <a:xfrm>
            <a:off x="394447" y="3396284"/>
            <a:ext cx="6131859" cy="2922051"/>
          </a:xfrm>
          <a:prstGeom prst="rect">
            <a:avLst/>
          </a:prstGeom>
          <a:noFill/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9316F1F8-5A96-4995-BDE6-E5A2B7B696CA}"/>
              </a:ext>
            </a:extLst>
          </p:cNvPr>
          <p:cNvSpPr/>
          <p:nvPr/>
        </p:nvSpPr>
        <p:spPr>
          <a:xfrm>
            <a:off x="394447" y="6446341"/>
            <a:ext cx="6131859" cy="2922051"/>
          </a:xfrm>
          <a:prstGeom prst="rect">
            <a:avLst/>
          </a:prstGeom>
          <a:noFill/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76107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6913E274-6153-42CD-9EDE-67B1BA65BA65}"/>
              </a:ext>
            </a:extLst>
          </p:cNvPr>
          <p:cNvGrpSpPr/>
          <p:nvPr/>
        </p:nvGrpSpPr>
        <p:grpSpPr>
          <a:xfrm>
            <a:off x="291354" y="90588"/>
            <a:ext cx="5957718" cy="8686800"/>
            <a:chOff x="277906" y="526292"/>
            <a:chExt cx="6131859" cy="8940711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B1C558D1-7735-46F7-8B80-0C637D7595AF}"/>
                </a:ext>
              </a:extLst>
            </p:cNvPr>
            <p:cNvSpPr txBox="1"/>
            <p:nvPr/>
          </p:nvSpPr>
          <p:spPr>
            <a:xfrm>
              <a:off x="946789" y="528968"/>
              <a:ext cx="19287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</a:p>
            <a:p>
              <a:pPr algn="ctr"/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up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R6h to R45m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9D8E0886-D482-4CC6-AA90-5FD08D8817E8}"/>
                </a:ext>
              </a:extLst>
            </p:cNvPr>
            <p:cNvSpPr txBox="1"/>
            <p:nvPr/>
          </p:nvSpPr>
          <p:spPr>
            <a:xfrm>
              <a:off x="3845676" y="528968"/>
              <a:ext cx="203132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own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R6h to R45m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A1E2CE10-0A50-455A-809F-2F26171715A9}"/>
                </a:ext>
              </a:extLst>
            </p:cNvPr>
            <p:cNvSpPr txBox="1"/>
            <p:nvPr/>
          </p:nvSpPr>
          <p:spPr>
            <a:xfrm>
              <a:off x="515276" y="567440"/>
              <a:ext cx="3016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1A59E879-E2B1-4E63-A725-00BC9E211A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205"/>
            <a:stretch/>
          </p:blipFill>
          <p:spPr>
            <a:xfrm>
              <a:off x="3550374" y="878990"/>
              <a:ext cx="2650027" cy="2583822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0A5A983A-AB03-493E-87DC-3B81AFAB20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341"/>
            <a:stretch/>
          </p:blipFill>
          <p:spPr>
            <a:xfrm>
              <a:off x="447953" y="878990"/>
              <a:ext cx="2832777" cy="2583822"/>
            </a:xfrm>
            <a:prstGeom prst="rect">
              <a:avLst/>
            </a:prstGeom>
          </p:spPr>
        </p:pic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97C8961D-2C66-46ED-BCC3-DB33558E9EF7}"/>
                </a:ext>
              </a:extLst>
            </p:cNvPr>
            <p:cNvSpPr txBox="1"/>
            <p:nvPr/>
          </p:nvSpPr>
          <p:spPr>
            <a:xfrm>
              <a:off x="860564" y="3549058"/>
              <a:ext cx="201529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</a:t>
              </a:r>
            </a:p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up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R1d to R45m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D12256EA-A9DB-4C57-AD2C-7BF84BD75A08}"/>
                </a:ext>
              </a:extLst>
            </p:cNvPr>
            <p:cNvSpPr txBox="1"/>
            <p:nvPr/>
          </p:nvSpPr>
          <p:spPr>
            <a:xfrm>
              <a:off x="3730259" y="3534151"/>
              <a:ext cx="21467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</a:t>
              </a:r>
            </a:p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own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R1d to R45min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FE91CD49-7382-4D67-B81B-6C1FCB72437A}"/>
                </a:ext>
              </a:extLst>
            </p:cNvPr>
            <p:cNvSpPr txBox="1"/>
            <p:nvPr/>
          </p:nvSpPr>
          <p:spPr>
            <a:xfrm>
              <a:off x="508111" y="3565196"/>
              <a:ext cx="2936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A5E22BA9-2026-407A-9471-A268F988C2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494"/>
            <a:stretch/>
          </p:blipFill>
          <p:spPr>
            <a:xfrm>
              <a:off x="3326823" y="3912149"/>
              <a:ext cx="2891370" cy="2590859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4E5AB6AB-7CAF-4C58-BC72-ECF76B7F4C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92" b="1"/>
            <a:stretch/>
          </p:blipFill>
          <p:spPr>
            <a:xfrm>
              <a:off x="455976" y="3903184"/>
              <a:ext cx="2824754" cy="2583238"/>
            </a:xfrm>
            <a:prstGeom prst="rect">
              <a:avLst/>
            </a:prstGeom>
          </p:spPr>
        </p:pic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66A9C6B8-04A5-4EE0-B18B-282C2E80B8A2}"/>
                </a:ext>
              </a:extLst>
            </p:cNvPr>
            <p:cNvSpPr txBox="1"/>
            <p:nvPr/>
          </p:nvSpPr>
          <p:spPr>
            <a:xfrm>
              <a:off x="1027254" y="6521716"/>
              <a:ext cx="176362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</a:p>
            <a:p>
              <a:pPr algn="ctr"/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up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R1d to R6h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5EABAA1B-F0DD-4966-9611-35D49C46DEAB}"/>
                </a:ext>
              </a:extLst>
            </p:cNvPr>
            <p:cNvSpPr txBox="1"/>
            <p:nvPr/>
          </p:nvSpPr>
          <p:spPr>
            <a:xfrm>
              <a:off x="3928669" y="6512751"/>
              <a:ext cx="186621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own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R1d to R6h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FF85A83D-CBAB-479F-BFF9-4822CF964DD4}"/>
                </a:ext>
              </a:extLst>
            </p:cNvPr>
            <p:cNvSpPr txBox="1"/>
            <p:nvPr/>
          </p:nvSpPr>
          <p:spPr>
            <a:xfrm>
              <a:off x="521441" y="6560471"/>
              <a:ext cx="2936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58C73F94-2FBE-419F-99A6-1E20E969D9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858" b="-1"/>
            <a:stretch/>
          </p:blipFill>
          <p:spPr>
            <a:xfrm>
              <a:off x="3241126" y="6884160"/>
              <a:ext cx="2988962" cy="2567747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F760CDEF-C3D8-4BE5-A57E-5ACA302E9E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858" b="-1"/>
            <a:stretch/>
          </p:blipFill>
          <p:spPr>
            <a:xfrm>
              <a:off x="589518" y="6884160"/>
              <a:ext cx="2651608" cy="2567747"/>
            </a:xfrm>
            <a:prstGeom prst="rect">
              <a:avLst/>
            </a:prstGeom>
          </p:spPr>
        </p:pic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C260615C-5C08-45E1-8A6D-A1E81B26E82E}"/>
                </a:ext>
              </a:extLst>
            </p:cNvPr>
            <p:cNvSpPr/>
            <p:nvPr/>
          </p:nvSpPr>
          <p:spPr>
            <a:xfrm>
              <a:off x="277906" y="526292"/>
              <a:ext cx="6131859" cy="2922051"/>
            </a:xfrm>
            <a:prstGeom prst="rect">
              <a:avLst/>
            </a:prstGeom>
            <a:noFill/>
            <a:ln w="1905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D014BA73-B8B3-43D8-9640-9B11CC61B9FE}"/>
                </a:ext>
              </a:extLst>
            </p:cNvPr>
            <p:cNvSpPr/>
            <p:nvPr/>
          </p:nvSpPr>
          <p:spPr>
            <a:xfrm>
              <a:off x="277906" y="3575579"/>
              <a:ext cx="6131859" cy="2922051"/>
            </a:xfrm>
            <a:prstGeom prst="rect">
              <a:avLst/>
            </a:prstGeom>
            <a:noFill/>
            <a:ln w="1905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" name="矩形 27">
              <a:extLst>
                <a:ext uri="{FF2B5EF4-FFF2-40B4-BE49-F238E27FC236}">
                  <a16:creationId xmlns:a16="http://schemas.microsoft.com/office/drawing/2014/main" id="{712F4995-12EC-4C37-B181-24D3487CA057}"/>
                </a:ext>
              </a:extLst>
            </p:cNvPr>
            <p:cNvSpPr/>
            <p:nvPr/>
          </p:nvSpPr>
          <p:spPr>
            <a:xfrm>
              <a:off x="277906" y="6544952"/>
              <a:ext cx="6131859" cy="2922051"/>
            </a:xfrm>
            <a:prstGeom prst="rect">
              <a:avLst/>
            </a:prstGeom>
            <a:noFill/>
            <a:ln w="19050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9" name="文本框 28">
            <a:extLst>
              <a:ext uri="{FF2B5EF4-FFF2-40B4-BE49-F238E27FC236}">
                <a16:creationId xmlns:a16="http://schemas.microsoft.com/office/drawing/2014/main" id="{63D3D966-93D1-4928-9B85-003C1E6846B8}"/>
              </a:ext>
            </a:extLst>
          </p:cNvPr>
          <p:cNvSpPr txBox="1"/>
          <p:nvPr/>
        </p:nvSpPr>
        <p:spPr>
          <a:xfrm>
            <a:off x="59250" y="8762720"/>
            <a:ext cx="67395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3. Kyoto Encyclopedia of Genes and Genomes database (KEGG) pathway enrichment of </a:t>
            </a:r>
            <a:r>
              <a:rPr lang="en-US" altLang="zh-CN" sz="1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. </a:t>
            </a:r>
            <a:r>
              <a:rPr lang="en-US" altLang="zh-CN" sz="1200" b="1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EGs over the rehydration process.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top 20 enriched pathways are indicated for upregulated and downregulated DEGs from comparisons between desiccated </a:t>
            </a:r>
            <a:r>
              <a:rPr lang="en-US" altLang="zh-CN" sz="12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. </a:t>
            </a:r>
            <a:r>
              <a:rPr lang="en-US" altLang="zh-CN" sz="12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R0) and rehydrated </a:t>
            </a:r>
            <a:r>
              <a:rPr lang="en-US" altLang="zh-CN" sz="12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. </a:t>
            </a:r>
            <a:r>
              <a:rPr lang="en-US" altLang="zh-CN" sz="12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fter 1 min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30 min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45 min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6 h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1 d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E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between 1 min and 30 min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F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1 min and 45 min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G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1 min and 6 h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H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1 min and 1 d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I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30 min and 45 min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J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30 min and 6 h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K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30 min and 1 d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L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45 min and 6 h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M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45 min and 1 d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N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or 6 h and 1 d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O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0741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51</TotalTime>
  <Words>547</Words>
  <Application>Microsoft Office PowerPoint</Application>
  <PresentationFormat>A4 纸张(210x297 毫米)</PresentationFormat>
  <Paragraphs>76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 Tianyi</dc:creator>
  <cp:lastModifiedBy>Ma Tianyi</cp:lastModifiedBy>
  <cp:revision>162</cp:revision>
  <dcterms:created xsi:type="dcterms:W3CDTF">2021-01-19T12:49:28Z</dcterms:created>
  <dcterms:modified xsi:type="dcterms:W3CDTF">2023-01-10T11:17:00Z</dcterms:modified>
</cp:coreProperties>
</file>